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CC61E-B270-4A68-9C76-A14372A8F2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38072-DE62-4667-A2FC-91005D3D3D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C3FA8-7BB9-4A4E-A456-5B5C38EA67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0BF07-4FF4-4973-975B-D2023E14EA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91031-09EE-4E20-A485-0AA7AE2BEC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8DEA0-9320-4F01-80E5-FC76F6E393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7E60D-70E4-4052-8FE6-B8C08D9118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D0825-AB90-48FF-A82A-5EF5B3825E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379C7-68EE-4680-B462-C3E6EB23BD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E6AFA-BB62-4908-84F8-E6A9D46B3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3072C-2204-4F39-9789-A9678FD93B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E9F54-A520-4212-8338-AA970B8175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EC6BCE-E71B-444C-BB8F-175B45B0CBA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36520" y="44280"/>
            <a:ext cx="8907480" cy="1031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Table 3.  FPRL1 use and amino acid sequences of the V3 loop for HIV-1 strains and isolat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Strain        Subtype      FPRL1 use</a:t>
            </a: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ells used for V3 loop sequence          Amino acid sequence of the V3 loop</a:t>
            </a: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***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 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                                               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                                                        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’                                  C’                                                                                          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1</a:t>
            </a:r>
            <a:r>
              <a:rPr b="0" lang="ja-JP" sz="1200" spc="-1" strike="noStrike">
                <a:solidFill>
                  <a:srgbClr val="ffffff"/>
                </a:solidFill>
                <a:latin typeface="ＭＳ ゴシック"/>
                <a:ea typeface="ＭＳ ゴシック"/>
              </a:rPr>
              <a:t>0000000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10</a:t>
            </a:r>
            <a:r>
              <a:rPr b="0" lang="ja-JP" sz="1200" spc="-1" strike="noStrike">
                <a:solidFill>
                  <a:srgbClr val="ffffff"/>
                </a:solidFill>
                <a:latin typeface="ＭＳ ゴシック"/>
                <a:ea typeface="ＭＳ ゴシック"/>
              </a:rPr>
              <a:t>00000000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20</a:t>
            </a:r>
            <a:r>
              <a:rPr b="0" lang="ja-JP" sz="1200" spc="-1" strike="noStrike">
                <a:solidFill>
                  <a:srgbClr val="ffffff"/>
                </a:solidFill>
                <a:latin typeface="ＭＳ ゴシック"/>
                <a:ea typeface="ＭＳ ゴシック"/>
              </a:rPr>
              <a:t>00000000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30      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III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CTRPNNNTRKSIRIQRGPGRAFVTIGKIIGNMRQAHC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                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Ba-L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....N.  ......Y.T.E...D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F162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....T.  ......YAT.D...D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UN-1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WT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....T.  ......HA.E.....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UN-1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V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....T.  .S....HA.E.....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UN-4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WT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S.GLS.  ......YASRR.T.D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UN-4V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S.GLF.  .S....YASRR.T.D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UN-7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WT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I........R.TM  ....VWY.T.E...DI.R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UN-7</a:t>
            </a:r>
            <a:r>
              <a:rPr b="0" lang="ja-JP" sz="10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V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B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I........R.TM  .T..VWY.T.E...DI.R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mIDU101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C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..........  ...QT.YAT.E...DI..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mSTD104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C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 and /FPRL1         ..............  ...QT.YAT.D....I.E..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AG204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 and /FPRL1         ....S..R.T....  ...QV.YQT.D....I.K.Y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AG206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 and /FPRL1         ....S....T....  ...QV.YRT.D....I.K.Y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HCM303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-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XCR4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....S....T..SM  ...QV.YRT.D...DI.K.Y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HCM309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XCR4 and /FPRL1        ....S....T..TM  ...QV.YRT.D...DI.K.Y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HCM305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 and /FPRL1         ....S....TRMTM  ...QV.YRT.D...DI.K.Y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HCM308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 and /FPRL1         ....S....T.TTM  ...QV.YRT.D...DI.K.Y.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HCM342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AE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++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	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P-2/CD4/CCR5 and /FPRL1         ....S.....G.T.  ...QI.YRT.D...DI.K.Y.</a:t>
            </a:r>
            <a:r>
              <a:rPr b="0" lang="ja-JP" sz="12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Ratios of HIV-1-positive cells on 6 day after viral inoculation are shown as follows: ≧ 50 %, +++;  10-49 %, ++; 1-9 %, +; an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1 %, -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**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Data of pairs of an HIV-1 strain using FPRL1 and an HIV-1 strain not using FPRL1 are boxed: these pairs of HIV-1 strain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harbored only one or two amino acid substitutions in the V3 loop between the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***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Amino acids matched to those of the III</a:t>
            </a: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strain is  indicated by "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"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Arial"/>
              </a:rPr>
              <a:t>****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Amino acid substitutions that may be related to FPRL1 use of HIV-1 strains are indicated by boxes with bold lin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6877080" y="2133720"/>
            <a:ext cx="71280" cy="35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877080" y="2637000"/>
            <a:ext cx="71280" cy="36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877080" y="3068640"/>
            <a:ext cx="71280" cy="36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6516720" y="2637000"/>
            <a:ext cx="71280" cy="36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6516720" y="4437000"/>
            <a:ext cx="71280" cy="432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124000" y="2133720"/>
            <a:ext cx="144360" cy="35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124000" y="2637000"/>
            <a:ext cx="144360" cy="35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2124000" y="2998800"/>
            <a:ext cx="216000" cy="358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2124000" y="4510080"/>
            <a:ext cx="144360" cy="358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24000" y="549360"/>
            <a:ext cx="813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24000" y="907920"/>
            <a:ext cx="813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24000" y="5516640"/>
            <a:ext cx="813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187000" y="2054160"/>
            <a:ext cx="302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6858720" y="198900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**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3T09:47:25Z</dcterms:created>
  <dc:creator>清水宣明</dc:creator>
  <dc:description/>
  <dc:language>en-US</dc:language>
  <cp:lastModifiedBy>清水宣明</cp:lastModifiedBy>
  <dcterms:modified xsi:type="dcterms:W3CDTF">2008-05-12T08:55:33Z</dcterms:modified>
  <cp:revision>6</cp:revision>
  <dc:subject/>
  <dc:title>スライド タイトルなし</dc:title>
</cp:coreProperties>
</file>